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1014" y="-7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668D-8C95-4E60-90A9-CB7261CF0908}" type="datetimeFigureOut">
              <a:rPr lang="en-US" smtClean="0"/>
              <a:t>2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02214-417A-4F2B-8AE3-EEBBD29AE2D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668D-8C95-4E60-90A9-CB7261CF0908}" type="datetimeFigureOut">
              <a:rPr lang="en-US" smtClean="0"/>
              <a:t>2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02214-417A-4F2B-8AE3-EEBBD29AE2D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668D-8C95-4E60-90A9-CB7261CF0908}" type="datetimeFigureOut">
              <a:rPr lang="en-US" smtClean="0"/>
              <a:t>2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02214-417A-4F2B-8AE3-EEBBD29AE2D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668D-8C95-4E60-90A9-CB7261CF0908}" type="datetimeFigureOut">
              <a:rPr lang="en-US" smtClean="0"/>
              <a:t>2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02214-417A-4F2B-8AE3-EEBBD29AE2D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668D-8C95-4E60-90A9-CB7261CF0908}" type="datetimeFigureOut">
              <a:rPr lang="en-US" smtClean="0"/>
              <a:t>2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02214-417A-4F2B-8AE3-EEBBD29AE2D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668D-8C95-4E60-90A9-CB7261CF0908}" type="datetimeFigureOut">
              <a:rPr lang="en-US" smtClean="0"/>
              <a:t>2/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02214-417A-4F2B-8AE3-EEBBD29AE2D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668D-8C95-4E60-90A9-CB7261CF0908}" type="datetimeFigureOut">
              <a:rPr lang="en-US" smtClean="0"/>
              <a:t>2/8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02214-417A-4F2B-8AE3-EEBBD29AE2D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668D-8C95-4E60-90A9-CB7261CF0908}" type="datetimeFigureOut">
              <a:rPr lang="en-US" smtClean="0"/>
              <a:t>2/8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02214-417A-4F2B-8AE3-EEBBD29AE2D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668D-8C95-4E60-90A9-CB7261CF0908}" type="datetimeFigureOut">
              <a:rPr lang="en-US" smtClean="0"/>
              <a:t>2/8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02214-417A-4F2B-8AE3-EEBBD29AE2D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668D-8C95-4E60-90A9-CB7261CF0908}" type="datetimeFigureOut">
              <a:rPr lang="en-US" smtClean="0"/>
              <a:t>2/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02214-417A-4F2B-8AE3-EEBBD29AE2D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668D-8C95-4E60-90A9-CB7261CF0908}" type="datetimeFigureOut">
              <a:rPr lang="en-US" smtClean="0"/>
              <a:t>2/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802214-417A-4F2B-8AE3-EEBBD29AE2D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0C668D-8C95-4E60-90A9-CB7261CF0908}" type="datetimeFigureOut">
              <a:rPr lang="en-US" smtClean="0"/>
              <a:t>2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802214-417A-4F2B-8AE3-EEBBD29AE2D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rarefaction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" y="914400"/>
            <a:ext cx="6172200" cy="401193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57201" y="5105400"/>
            <a:ext cx="6019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upplementary figure 1S. Rarefaction plot of the unique sequences in saliva samples of three oral health groups of children with early mixed dentition (healthy, treated or with caries).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2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ACT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zaura</dc:creator>
  <cp:lastModifiedBy>ezaura</cp:lastModifiedBy>
  <cp:revision>3</cp:revision>
  <dcterms:created xsi:type="dcterms:W3CDTF">2011-02-08T13:43:49Z</dcterms:created>
  <dcterms:modified xsi:type="dcterms:W3CDTF">2011-02-08T13:49:50Z</dcterms:modified>
</cp:coreProperties>
</file>